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DD2164-94B6-4566-A0C4-D8B8993C022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32F412-48D2-4D49-9B9B-42EB0058F2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2DC886-2073-4F2F-B171-62745E72FCD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F68D0E-D168-49DF-9853-0C6AAFD0626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449DDD-0634-4B1F-A4B7-F92EDC4D170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7E6C48-3B86-4AAD-8190-FA976090A5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3BF1FC-DC2D-41D8-9860-E47F4F63BC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484C88-247D-402B-ADC9-58DDE7FD3D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38130C-8CAF-40A5-AF9A-714AC3B0A6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7E8762-2F31-40D7-931A-896898E182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326176-40B5-485A-875E-4B6B43B65C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E45206-0E77-4DDD-9F32-75FF4300C9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39C7CE5-96D5-40BF-9304-24A6E046C5D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129240" y="817920"/>
            <a:ext cx="7905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9. Improvement of cross-platform correlations with different number of PCs in GAM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hart 9" descr=""/>
          <p:cNvPicPr/>
          <p:nvPr/>
        </p:nvPicPr>
        <p:blipFill>
          <a:blip r:embed="rId1"/>
          <a:stretch/>
        </p:blipFill>
        <p:spPr>
          <a:xfrm>
            <a:off x="390600" y="1335240"/>
            <a:ext cx="8217000" cy="4767120"/>
          </a:xfrm>
          <a:prstGeom prst="rect">
            <a:avLst/>
          </a:prstGeom>
          <a:ln w="0">
            <a:noFill/>
          </a:ln>
        </p:spPr>
      </p:pic>
      <p:pic>
        <p:nvPicPr>
          <p:cNvPr id="43" name="TextBox 10" descr=""/>
          <p:cNvPicPr/>
          <p:nvPr/>
        </p:nvPicPr>
        <p:blipFill>
          <a:blip r:embed="rId2"/>
          <a:stretch/>
        </p:blipFill>
        <p:spPr>
          <a:xfrm>
            <a:off x="103320" y="2133720"/>
            <a:ext cx="469800" cy="1609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6T17:28:43Z</dcterms:created>
  <dc:creator>Wei Zheng</dc:creator>
  <dc:description/>
  <dc:language>en-US</dc:language>
  <cp:lastModifiedBy>Wei Zheng</cp:lastModifiedBy>
  <dcterms:modified xsi:type="dcterms:W3CDTF">2011-06-06T17:29:18Z</dcterms:modified>
  <cp:revision>1</cp:revision>
  <dc:subject/>
  <dc:title>Slide 1</dc:title>
</cp:coreProperties>
</file>